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33FF"/>
    <a:srgbClr val="00B0F0"/>
    <a:srgbClr val="FF0000"/>
    <a:srgbClr val="CC3300"/>
    <a:srgbClr val="81E7E5"/>
    <a:srgbClr val="00CC00"/>
    <a:srgbClr val="FFFF00"/>
    <a:srgbClr val="CC66FF"/>
    <a:srgbClr val="CC00FF"/>
    <a:srgbClr val="C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442" autoAdjust="0"/>
    <p:restoredTop sz="94061" autoAdjust="0"/>
  </p:normalViewPr>
  <p:slideViewPr>
    <p:cSldViewPr snapToGrid="0">
      <p:cViewPr varScale="1">
        <p:scale>
          <a:sx n="81" d="100"/>
          <a:sy n="81" d="100"/>
        </p:scale>
        <p:origin x="364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XDH%20&#23454;&#39564;&#25968;&#25454;&#12289;&#32467;&#26524;\XDH&#12289;&#23450;&#37327;&#30456;&#20851;\&#30456;&#20851;&#23450;&#37327;&#12289;123&#12289;&#25972;&#21512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XDH%20&#23454;&#39564;&#25968;&#25454;&#12289;&#32467;&#26524;\XDH&#12289;&#23450;&#37327;&#30456;&#20851;\&#30456;&#20851;&#23450;&#37327;&#12289;123&#12289;&#25972;&#21512;%20&#12289;&#20462;&#25913;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46522309711285"/>
          <c:y val="7.407407407407407E-2"/>
          <c:w val="0.8659875343224821"/>
          <c:h val="0.793396111588513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40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203-4A60-915D-BE50A86BD8A2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C$43:$X$43</c:f>
                <c:numCache>
                  <c:formatCode>General</c:formatCode>
                  <c:ptCount val="21"/>
                  <c:pt idx="0">
                    <c:v>9.1968991881165904E-2</c:v>
                  </c:pt>
                  <c:pt idx="1">
                    <c:v>9.5061459932706302E-2</c:v>
                  </c:pt>
                  <c:pt idx="2">
                    <c:v>9.3393071367879402E-2</c:v>
                  </c:pt>
                  <c:pt idx="3">
                    <c:v>9.2769962521640797E-2</c:v>
                  </c:pt>
                  <c:pt idx="4">
                    <c:v>9.3084312681692996E-2</c:v>
                  </c:pt>
                  <c:pt idx="5">
                    <c:v>9.3807926088890395E-2</c:v>
                  </c:pt>
                  <c:pt idx="6">
                    <c:v>0.13599681175799899</c:v>
                  </c:pt>
                  <c:pt idx="7">
                    <c:v>9.3486217373343103E-2</c:v>
                  </c:pt>
                  <c:pt idx="8">
                    <c:v>9.2042034848895504E-2</c:v>
                  </c:pt>
                  <c:pt idx="9">
                    <c:v>0.100775475623474</c:v>
                  </c:pt>
                  <c:pt idx="10">
                    <c:v>9.2695594326769395E-2</c:v>
                  </c:pt>
                  <c:pt idx="11">
                    <c:v>9.4562480199761906E-2</c:v>
                  </c:pt>
                  <c:pt idx="12">
                    <c:v>9.4780241850312197E-2</c:v>
                  </c:pt>
                  <c:pt idx="13">
                    <c:v>2.6690588965438099E-2</c:v>
                  </c:pt>
                  <c:pt idx="14">
                    <c:v>4.33508540784035E-2</c:v>
                  </c:pt>
                  <c:pt idx="15">
                    <c:v>3.3660063950462102E-2</c:v>
                  </c:pt>
                  <c:pt idx="16">
                    <c:v>9.3430178475041606E-2</c:v>
                  </c:pt>
                  <c:pt idx="17">
                    <c:v>9.5268865252405202E-2</c:v>
                  </c:pt>
                  <c:pt idx="18">
                    <c:v>2.4781380270946E-2</c:v>
                  </c:pt>
                  <c:pt idx="19">
                    <c:v>3.5712147487555398E-2</c:v>
                  </c:pt>
                  <c:pt idx="20">
                    <c:v>2.4514505239574401E-2</c:v>
                  </c:pt>
                </c:numCache>
                <c:extLst/>
              </c:numRef>
            </c:plus>
            <c:minus>
              <c:numRef>
                <c:f>Sheet1!$C$43:$X$43</c:f>
                <c:numCache>
                  <c:formatCode>General</c:formatCode>
                  <c:ptCount val="21"/>
                  <c:pt idx="0">
                    <c:v>9.1968991881165904E-2</c:v>
                  </c:pt>
                  <c:pt idx="1">
                    <c:v>9.5061459932706302E-2</c:v>
                  </c:pt>
                  <c:pt idx="2">
                    <c:v>9.3393071367879402E-2</c:v>
                  </c:pt>
                  <c:pt idx="3">
                    <c:v>9.2769962521640797E-2</c:v>
                  </c:pt>
                  <c:pt idx="4">
                    <c:v>9.3084312681692996E-2</c:v>
                  </c:pt>
                  <c:pt idx="5">
                    <c:v>9.3807926088890395E-2</c:v>
                  </c:pt>
                  <c:pt idx="6">
                    <c:v>0.13599681175799899</c:v>
                  </c:pt>
                  <c:pt idx="7">
                    <c:v>9.3486217373343103E-2</c:v>
                  </c:pt>
                  <c:pt idx="8">
                    <c:v>9.2042034848895504E-2</c:v>
                  </c:pt>
                  <c:pt idx="9">
                    <c:v>0.100775475623474</c:v>
                  </c:pt>
                  <c:pt idx="10">
                    <c:v>9.2695594326769395E-2</c:v>
                  </c:pt>
                  <c:pt idx="11">
                    <c:v>9.4562480199761906E-2</c:v>
                  </c:pt>
                  <c:pt idx="12">
                    <c:v>9.4780241850312197E-2</c:v>
                  </c:pt>
                  <c:pt idx="13">
                    <c:v>2.6690588965438099E-2</c:v>
                  </c:pt>
                  <c:pt idx="14">
                    <c:v>4.33508540784035E-2</c:v>
                  </c:pt>
                  <c:pt idx="15">
                    <c:v>3.3660063950462102E-2</c:v>
                  </c:pt>
                  <c:pt idx="16">
                    <c:v>9.3430178475041606E-2</c:v>
                  </c:pt>
                  <c:pt idx="17">
                    <c:v>9.5268865252405202E-2</c:v>
                  </c:pt>
                  <c:pt idx="18">
                    <c:v>2.4781380270946E-2</c:v>
                  </c:pt>
                  <c:pt idx="19">
                    <c:v>3.5712147487555398E-2</c:v>
                  </c:pt>
                  <c:pt idx="20">
                    <c:v>2.4514505239574401E-2</c:v>
                  </c:pt>
                </c:numCache>
                <c:extLst/>
              </c:numRef>
            </c:minus>
          </c:errBars>
          <c:cat>
            <c:strRef>
              <c:f>Sheet1!$C$39:$X$39</c:f>
              <c:strCache>
                <c:ptCount val="21"/>
                <c:pt idx="0">
                  <c:v>psaA</c:v>
                </c:pt>
                <c:pt idx="1">
                  <c:v>psaB</c:v>
                </c:pt>
                <c:pt idx="2">
                  <c:v>psaC</c:v>
                </c:pt>
                <c:pt idx="3">
                  <c:v>psaD</c:v>
                </c:pt>
                <c:pt idx="4">
                  <c:v>psaE</c:v>
                </c:pt>
                <c:pt idx="5">
                  <c:v>psaF</c:v>
                </c:pt>
                <c:pt idx="6">
                  <c:v>psaH</c:v>
                </c:pt>
                <c:pt idx="7">
                  <c:v>psaL</c:v>
                </c:pt>
                <c:pt idx="8">
                  <c:v>psbA</c:v>
                </c:pt>
                <c:pt idx="9">
                  <c:v>psbB</c:v>
                </c:pt>
                <c:pt idx="10">
                  <c:v>psbC</c:v>
                </c:pt>
                <c:pt idx="11">
                  <c:v>psbD</c:v>
                </c:pt>
                <c:pt idx="12">
                  <c:v>psbE</c:v>
                </c:pt>
                <c:pt idx="13">
                  <c:v>psbF</c:v>
                </c:pt>
                <c:pt idx="14">
                  <c:v>psbO</c:v>
                </c:pt>
                <c:pt idx="15">
                  <c:v>psbY</c:v>
                </c:pt>
                <c:pt idx="16">
                  <c:v>rbcL</c:v>
                </c:pt>
                <c:pt idx="17">
                  <c:v>rbcS</c:v>
                </c:pt>
                <c:pt idx="18">
                  <c:v>atpA</c:v>
                </c:pt>
                <c:pt idx="19">
                  <c:v>atpB</c:v>
                </c:pt>
                <c:pt idx="20">
                  <c:v>atpG</c:v>
                </c:pt>
              </c:strCache>
              <c:extLst/>
            </c:strRef>
          </c:cat>
          <c:val>
            <c:numRef>
              <c:f>Sheet1!$C$40:$X$40</c:f>
              <c:numCache>
                <c:formatCode>General</c:formatCode>
                <c:ptCount val="2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B203-4A60-915D-BE50A86BD8A2}"/>
            </c:ext>
          </c:extLst>
        </c:ser>
        <c:ser>
          <c:idx val="1"/>
          <c:order val="1"/>
          <c:tx>
            <c:strRef>
              <c:f>Sheet1!$B$41</c:f>
              <c:strCache>
                <c:ptCount val="1"/>
                <c:pt idx="0">
                  <c:v>ossac3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B203-4A60-915D-BE50A86BD8A2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C$44:$X$44</c:f>
                <c:numCache>
                  <c:formatCode>General</c:formatCode>
                  <c:ptCount val="21"/>
                  <c:pt idx="0">
                    <c:v>2.3829102717110098E-2</c:v>
                  </c:pt>
                  <c:pt idx="1">
                    <c:v>1.52282442194093E-2</c:v>
                  </c:pt>
                  <c:pt idx="2">
                    <c:v>1.1556931218439001E-2</c:v>
                  </c:pt>
                  <c:pt idx="3">
                    <c:v>9.6994532851926302E-3</c:v>
                  </c:pt>
                  <c:pt idx="4">
                    <c:v>8.9877136282250098E-3</c:v>
                  </c:pt>
                  <c:pt idx="5">
                    <c:v>7.15305152479658E-3</c:v>
                  </c:pt>
                  <c:pt idx="6">
                    <c:v>1.1957342073659401E-2</c:v>
                  </c:pt>
                  <c:pt idx="7">
                    <c:v>9.1177775930510099E-3</c:v>
                  </c:pt>
                  <c:pt idx="8">
                    <c:v>1.03846958871736E-2</c:v>
                  </c:pt>
                  <c:pt idx="9">
                    <c:v>1.7941447493916001E-2</c:v>
                  </c:pt>
                  <c:pt idx="10">
                    <c:v>1.36540638375137E-2</c:v>
                  </c:pt>
                  <c:pt idx="11">
                    <c:v>1.62948305193092E-2</c:v>
                  </c:pt>
                  <c:pt idx="12">
                    <c:v>1.0596215419527001E-2</c:v>
                  </c:pt>
                  <c:pt idx="13">
                    <c:v>1.19288704328986E-2</c:v>
                  </c:pt>
                  <c:pt idx="14">
                    <c:v>2.0300828333822001E-2</c:v>
                  </c:pt>
                  <c:pt idx="15">
                    <c:v>7.9914076852278006E-3</c:v>
                  </c:pt>
                  <c:pt idx="16">
                    <c:v>9.1343760111753398E-3</c:v>
                  </c:pt>
                  <c:pt idx="17">
                    <c:v>9.9478057572984797E-3</c:v>
                  </c:pt>
                  <c:pt idx="18">
                    <c:v>1.84223652865819E-2</c:v>
                  </c:pt>
                  <c:pt idx="19">
                    <c:v>1.51485546644542E-2</c:v>
                  </c:pt>
                  <c:pt idx="20">
                    <c:v>1.1755150020982799E-2</c:v>
                  </c:pt>
                </c:numCache>
                <c:extLst/>
              </c:numRef>
            </c:plus>
            <c:minus>
              <c:numRef>
                <c:f>Sheet1!$C$44:$X$44</c:f>
                <c:numCache>
                  <c:formatCode>General</c:formatCode>
                  <c:ptCount val="21"/>
                  <c:pt idx="0">
                    <c:v>2.3829102717110098E-2</c:v>
                  </c:pt>
                  <c:pt idx="1">
                    <c:v>1.52282442194093E-2</c:v>
                  </c:pt>
                  <c:pt idx="2">
                    <c:v>1.1556931218439001E-2</c:v>
                  </c:pt>
                  <c:pt idx="3">
                    <c:v>9.6994532851926302E-3</c:v>
                  </c:pt>
                  <c:pt idx="4">
                    <c:v>8.9877136282250098E-3</c:v>
                  </c:pt>
                  <c:pt idx="5">
                    <c:v>7.15305152479658E-3</c:v>
                  </c:pt>
                  <c:pt idx="6">
                    <c:v>1.1957342073659401E-2</c:v>
                  </c:pt>
                  <c:pt idx="7">
                    <c:v>9.1177775930510099E-3</c:v>
                  </c:pt>
                  <c:pt idx="8">
                    <c:v>1.03846958871736E-2</c:v>
                  </c:pt>
                  <c:pt idx="9">
                    <c:v>1.7941447493916001E-2</c:v>
                  </c:pt>
                  <c:pt idx="10">
                    <c:v>1.36540638375137E-2</c:v>
                  </c:pt>
                  <c:pt idx="11">
                    <c:v>1.62948305193092E-2</c:v>
                  </c:pt>
                  <c:pt idx="12">
                    <c:v>1.0596215419527001E-2</c:v>
                  </c:pt>
                  <c:pt idx="13">
                    <c:v>1.19288704328986E-2</c:v>
                  </c:pt>
                  <c:pt idx="14">
                    <c:v>2.0300828333822001E-2</c:v>
                  </c:pt>
                  <c:pt idx="15">
                    <c:v>7.9914076852278006E-3</c:v>
                  </c:pt>
                  <c:pt idx="16">
                    <c:v>9.1343760111753398E-3</c:v>
                  </c:pt>
                  <c:pt idx="17">
                    <c:v>9.9478057572984797E-3</c:v>
                  </c:pt>
                  <c:pt idx="18">
                    <c:v>1.84223652865819E-2</c:v>
                  </c:pt>
                  <c:pt idx="19">
                    <c:v>1.51485546644542E-2</c:v>
                  </c:pt>
                  <c:pt idx="20">
                    <c:v>1.1755150020982799E-2</c:v>
                  </c:pt>
                </c:numCache>
                <c:extLst/>
              </c:numRef>
            </c:minus>
          </c:errBars>
          <c:cat>
            <c:strRef>
              <c:f>Sheet1!$C$39:$X$39</c:f>
              <c:strCache>
                <c:ptCount val="21"/>
                <c:pt idx="0">
                  <c:v>psaA</c:v>
                </c:pt>
                <c:pt idx="1">
                  <c:v>psaB</c:v>
                </c:pt>
                <c:pt idx="2">
                  <c:v>psaC</c:v>
                </c:pt>
                <c:pt idx="3">
                  <c:v>psaD</c:v>
                </c:pt>
                <c:pt idx="4">
                  <c:v>psaE</c:v>
                </c:pt>
                <c:pt idx="5">
                  <c:v>psaF</c:v>
                </c:pt>
                <c:pt idx="6">
                  <c:v>psaH</c:v>
                </c:pt>
                <c:pt idx="7">
                  <c:v>psaL</c:v>
                </c:pt>
                <c:pt idx="8">
                  <c:v>psbA</c:v>
                </c:pt>
                <c:pt idx="9">
                  <c:v>psbB</c:v>
                </c:pt>
                <c:pt idx="10">
                  <c:v>psbC</c:v>
                </c:pt>
                <c:pt idx="11">
                  <c:v>psbD</c:v>
                </c:pt>
                <c:pt idx="12">
                  <c:v>psbE</c:v>
                </c:pt>
                <c:pt idx="13">
                  <c:v>psbF</c:v>
                </c:pt>
                <c:pt idx="14">
                  <c:v>psbO</c:v>
                </c:pt>
                <c:pt idx="15">
                  <c:v>psbY</c:v>
                </c:pt>
                <c:pt idx="16">
                  <c:v>rbcL</c:v>
                </c:pt>
                <c:pt idx="17">
                  <c:v>rbcS</c:v>
                </c:pt>
                <c:pt idx="18">
                  <c:v>atpA</c:v>
                </c:pt>
                <c:pt idx="19">
                  <c:v>atpB</c:v>
                </c:pt>
                <c:pt idx="20">
                  <c:v>atpG</c:v>
                </c:pt>
              </c:strCache>
              <c:extLst/>
            </c:strRef>
          </c:cat>
          <c:val>
            <c:numRef>
              <c:f>Sheet1!$C$41:$X$41</c:f>
              <c:numCache>
                <c:formatCode>General</c:formatCode>
                <c:ptCount val="21"/>
                <c:pt idx="0">
                  <c:v>0.43769745393942899</c:v>
                </c:pt>
                <c:pt idx="1">
                  <c:v>0.43194527459151799</c:v>
                </c:pt>
                <c:pt idx="2">
                  <c:v>0.26737775492704902</c:v>
                </c:pt>
                <c:pt idx="3">
                  <c:v>0.238780417027769</c:v>
                </c:pt>
                <c:pt idx="4">
                  <c:v>0.212326468183583</c:v>
                </c:pt>
                <c:pt idx="5">
                  <c:v>0.20352133254362001</c:v>
                </c:pt>
                <c:pt idx="6">
                  <c:v>0.257990470449044</c:v>
                </c:pt>
                <c:pt idx="7">
                  <c:v>0.231137128027019</c:v>
                </c:pt>
                <c:pt idx="8">
                  <c:v>0.27134278217546598</c:v>
                </c:pt>
                <c:pt idx="9">
                  <c:v>0.49990563472136201</c:v>
                </c:pt>
                <c:pt idx="10">
                  <c:v>0.35632285585751</c:v>
                </c:pt>
                <c:pt idx="11">
                  <c:v>0.418258094879844</c:v>
                </c:pt>
                <c:pt idx="12">
                  <c:v>0.200990238691896</c:v>
                </c:pt>
                <c:pt idx="13">
                  <c:v>0.29272584618382502</c:v>
                </c:pt>
                <c:pt idx="14">
                  <c:v>0.18514972089347401</c:v>
                </c:pt>
                <c:pt idx="15">
                  <c:v>0.165133629139018</c:v>
                </c:pt>
                <c:pt idx="16">
                  <c:v>0.19475287572472999</c:v>
                </c:pt>
                <c:pt idx="17">
                  <c:v>0.13428901942268401</c:v>
                </c:pt>
                <c:pt idx="18">
                  <c:v>0.35791942468563998</c:v>
                </c:pt>
                <c:pt idx="19">
                  <c:v>0.36029712490391802</c:v>
                </c:pt>
                <c:pt idx="20">
                  <c:v>0.2869475763093580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5-B203-4A60-915D-BE50A86BD8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3665456"/>
        <c:axId val="953659472"/>
      </c:barChart>
      <c:catAx>
        <c:axId val="953665456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53659472"/>
        <c:crosses val="autoZero"/>
        <c:auto val="1"/>
        <c:lblAlgn val="ctr"/>
        <c:lblOffset val="100"/>
        <c:noMultiLvlLbl val="0"/>
      </c:catAx>
      <c:valAx>
        <c:axId val="9536594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>
                    <a:latin typeface="Times New Roman" pitchFamily="18" charset="0"/>
                    <a:cs typeface="Times New Roman" pitchFamily="18" charset="0"/>
                  </a:rPr>
                  <a:t>Ralative Expretion Level</a:t>
                </a:r>
                <a:endParaRPr lang="zh-CN" altLang="en-US">
                  <a:latin typeface="Times New Roman" pitchFamily="18" charset="0"/>
                  <a:cs typeface="Times New Roman" pitchFamily="18" charset="0"/>
                </a:endParaRPr>
              </a:p>
            </c:rich>
          </c:tx>
          <c:overlay val="0"/>
        </c:title>
        <c:numFmt formatCode="#,##0.0_);[Red]\(#,##0.0\)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53665456"/>
        <c:crosses val="autoZero"/>
        <c:crossBetween val="between"/>
      </c:valAx>
    </c:plotArea>
    <c:legend>
      <c:legendPos val="r"/>
      <c:legendEntry>
        <c:idx val="1"/>
        <c:txPr>
          <a:bodyPr/>
          <a:lstStyle/>
          <a:p>
            <a:pPr>
              <a:defRPr i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68391797900262463"/>
          <c:y val="6.9060586176727903E-2"/>
          <c:w val="0.22163757655293087"/>
          <c:h val="7.9471420239136767E-2"/>
        </c:manualLayout>
      </c:layout>
      <c:overlay val="0"/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696050999916465"/>
          <c:y val="6.5493525318760862E-2"/>
          <c:w val="0.84423408612384987"/>
          <c:h val="0.748040852972356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 w="0"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Sheet1!$C$5:$R$5</c:f>
                <c:numCache>
                  <c:formatCode>General</c:formatCode>
                  <c:ptCount val="14"/>
                  <c:pt idx="0">
                    <c:v>4.51229222368765E-2</c:v>
                  </c:pt>
                  <c:pt idx="1">
                    <c:v>4.0347297104546397E-2</c:v>
                  </c:pt>
                  <c:pt idx="2">
                    <c:v>6.5587165956359203E-2</c:v>
                  </c:pt>
                  <c:pt idx="3">
                    <c:v>4.3226097161933902E-2</c:v>
                  </c:pt>
                  <c:pt idx="4">
                    <c:v>0.11943004120393</c:v>
                  </c:pt>
                  <c:pt idx="5">
                    <c:v>3.79355152815039E-2</c:v>
                  </c:pt>
                  <c:pt idx="6">
                    <c:v>4.11567692811882E-2</c:v>
                  </c:pt>
                  <c:pt idx="7">
                    <c:v>4.0487266980885499E-2</c:v>
                  </c:pt>
                  <c:pt idx="8">
                    <c:v>8.3372864735673999E-2</c:v>
                  </c:pt>
                  <c:pt idx="9">
                    <c:v>3.8820638465826299E-2</c:v>
                  </c:pt>
                  <c:pt idx="10">
                    <c:v>3.8464432490297899E-2</c:v>
                  </c:pt>
                  <c:pt idx="11">
                    <c:v>4.1081301964512602E-2</c:v>
                  </c:pt>
                  <c:pt idx="12">
                    <c:v>3.7747991760643702E-2</c:v>
                  </c:pt>
                  <c:pt idx="13">
                    <c:v>4.20338452150106E-2</c:v>
                  </c:pt>
                </c:numCache>
                <c:extLst/>
              </c:numRef>
            </c:plus>
            <c:minus>
              <c:numRef>
                <c:f>Sheet1!$C$5:$R$5</c:f>
                <c:numCache>
                  <c:formatCode>General</c:formatCode>
                  <c:ptCount val="14"/>
                  <c:pt idx="0">
                    <c:v>4.51229222368765E-2</c:v>
                  </c:pt>
                  <c:pt idx="1">
                    <c:v>4.0347297104546397E-2</c:v>
                  </c:pt>
                  <c:pt idx="2">
                    <c:v>6.5587165956359203E-2</c:v>
                  </c:pt>
                  <c:pt idx="3">
                    <c:v>4.3226097161933902E-2</c:v>
                  </c:pt>
                  <c:pt idx="4">
                    <c:v>0.11943004120393</c:v>
                  </c:pt>
                  <c:pt idx="5">
                    <c:v>3.79355152815039E-2</c:v>
                  </c:pt>
                  <c:pt idx="6">
                    <c:v>4.11567692811882E-2</c:v>
                  </c:pt>
                  <c:pt idx="7">
                    <c:v>4.0487266980885499E-2</c:v>
                  </c:pt>
                  <c:pt idx="8">
                    <c:v>8.3372864735673999E-2</c:v>
                  </c:pt>
                  <c:pt idx="9">
                    <c:v>3.8820638465826299E-2</c:v>
                  </c:pt>
                  <c:pt idx="10">
                    <c:v>3.8464432490297899E-2</c:v>
                  </c:pt>
                  <c:pt idx="11">
                    <c:v>4.1081301964512602E-2</c:v>
                  </c:pt>
                  <c:pt idx="12">
                    <c:v>3.7747991760643702E-2</c:v>
                  </c:pt>
                  <c:pt idx="13">
                    <c:v>4.20338452150106E-2</c:v>
                  </c:pt>
                </c:numCache>
                <c:extLst/>
              </c:numRef>
            </c:minus>
          </c:errBars>
          <c:cat>
            <c:strRef>
              <c:f>Sheet1!$C$1:$R$1</c:f>
              <c:strCache>
                <c:ptCount val="14"/>
                <c:pt idx="0">
                  <c:v>CAO1</c:v>
                </c:pt>
                <c:pt idx="1">
                  <c:v>CHL1</c:v>
                </c:pt>
                <c:pt idx="2">
                  <c:v>CHLD</c:v>
                </c:pt>
                <c:pt idx="3">
                  <c:v>CHLM</c:v>
                </c:pt>
                <c:pt idx="4">
                  <c:v>DVR</c:v>
                </c:pt>
                <c:pt idx="5">
                  <c:v>HEMA1</c:v>
                </c:pt>
                <c:pt idx="6">
                  <c:v>HEMC</c:v>
                </c:pt>
                <c:pt idx="7">
                  <c:v>HEMD</c:v>
                </c:pt>
                <c:pt idx="8">
                  <c:v>HEME</c:v>
                </c:pt>
                <c:pt idx="9">
                  <c:v>PDS</c:v>
                </c:pt>
                <c:pt idx="10">
                  <c:v>PORA</c:v>
                </c:pt>
                <c:pt idx="11">
                  <c:v>PSY1</c:v>
                </c:pt>
                <c:pt idx="12">
                  <c:v>PSY2</c:v>
                </c:pt>
                <c:pt idx="13">
                  <c:v>PSY3</c:v>
                </c:pt>
              </c:strCache>
              <c:extLst/>
            </c:strRef>
          </c:cat>
          <c:val>
            <c:numRef>
              <c:f>Sheet1!$C$2:$R$2</c:f>
              <c:numCache>
                <c:formatCode>General</c:formatCode>
                <c:ptCount val="1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D92B-458C-8A05-C51723DF13BA}"/>
            </c:ext>
          </c:extLst>
        </c:ser>
        <c:ser>
          <c:idx val="1"/>
          <c:order val="1"/>
          <c:tx>
            <c:strRef>
              <c:f>Sheet1!$B$3</c:f>
              <c:strCache>
                <c:ptCount val="1"/>
                <c:pt idx="0">
                  <c:v>ossac3</c:v>
                </c:pt>
              </c:strCache>
            </c:strRef>
          </c:tx>
          <c:spPr>
            <a:noFill/>
            <a:ln w="0">
              <a:solidFill>
                <a:schemeClr val="tx1"/>
              </a:solidFill>
            </a:ln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Sheet1!$C$6:$R$6</c:f>
                <c:numCache>
                  <c:formatCode>General</c:formatCode>
                  <c:ptCount val="14"/>
                  <c:pt idx="0">
                    <c:v>2.5264663421383001E-2</c:v>
                  </c:pt>
                  <c:pt idx="1">
                    <c:v>1.72243549946333E-2</c:v>
                  </c:pt>
                  <c:pt idx="2">
                    <c:v>6.4402786791021002E-2</c:v>
                  </c:pt>
                  <c:pt idx="3">
                    <c:v>7.1532327881478799E-2</c:v>
                  </c:pt>
                  <c:pt idx="4">
                    <c:v>4.0893315224220003E-2</c:v>
                  </c:pt>
                  <c:pt idx="5">
                    <c:v>9.6754034736231398E-3</c:v>
                  </c:pt>
                  <c:pt idx="6">
                    <c:v>0.10037093102756001</c:v>
                  </c:pt>
                  <c:pt idx="7">
                    <c:v>3.2620244780462798E-2</c:v>
                  </c:pt>
                  <c:pt idx="8">
                    <c:v>7.9420401454862594E-2</c:v>
                  </c:pt>
                  <c:pt idx="9">
                    <c:v>4.3507660496975402E-2</c:v>
                  </c:pt>
                  <c:pt idx="10">
                    <c:v>1.9864377248775801E-2</c:v>
                  </c:pt>
                  <c:pt idx="11">
                    <c:v>2.7646464819068101E-2</c:v>
                  </c:pt>
                  <c:pt idx="12">
                    <c:v>2.1986187615990901E-2</c:v>
                  </c:pt>
                  <c:pt idx="13">
                    <c:v>7.4170916989500804E-2</c:v>
                  </c:pt>
                </c:numCache>
                <c:extLst/>
              </c:numRef>
            </c:plus>
            <c:minus>
              <c:numRef>
                <c:f>Sheet1!$C$6:$R$6</c:f>
                <c:numCache>
                  <c:formatCode>General</c:formatCode>
                  <c:ptCount val="14"/>
                  <c:pt idx="0">
                    <c:v>2.5264663421383001E-2</c:v>
                  </c:pt>
                  <c:pt idx="1">
                    <c:v>1.72243549946333E-2</c:v>
                  </c:pt>
                  <c:pt idx="2">
                    <c:v>6.4402786791021002E-2</c:v>
                  </c:pt>
                  <c:pt idx="3">
                    <c:v>7.1532327881478799E-2</c:v>
                  </c:pt>
                  <c:pt idx="4">
                    <c:v>4.0893315224220003E-2</c:v>
                  </c:pt>
                  <c:pt idx="5">
                    <c:v>9.6754034736231398E-3</c:v>
                  </c:pt>
                  <c:pt idx="6">
                    <c:v>0.10037093102756001</c:v>
                  </c:pt>
                  <c:pt idx="7">
                    <c:v>3.2620244780462798E-2</c:v>
                  </c:pt>
                  <c:pt idx="8">
                    <c:v>7.9420401454862594E-2</c:v>
                  </c:pt>
                  <c:pt idx="9">
                    <c:v>4.3507660496975402E-2</c:v>
                  </c:pt>
                  <c:pt idx="10">
                    <c:v>1.9864377248775801E-2</c:v>
                  </c:pt>
                  <c:pt idx="11">
                    <c:v>2.7646464819068101E-2</c:v>
                  </c:pt>
                  <c:pt idx="12">
                    <c:v>2.1986187615990901E-2</c:v>
                  </c:pt>
                  <c:pt idx="13">
                    <c:v>7.4170916989500804E-2</c:v>
                  </c:pt>
                </c:numCache>
                <c:extLst/>
              </c:numRef>
            </c:minus>
          </c:errBars>
          <c:cat>
            <c:strRef>
              <c:f>Sheet1!$C$1:$R$1</c:f>
              <c:strCache>
                <c:ptCount val="14"/>
                <c:pt idx="0">
                  <c:v>CAO1</c:v>
                </c:pt>
                <c:pt idx="1">
                  <c:v>CHL1</c:v>
                </c:pt>
                <c:pt idx="2">
                  <c:v>CHLD</c:v>
                </c:pt>
                <c:pt idx="3">
                  <c:v>CHLM</c:v>
                </c:pt>
                <c:pt idx="4">
                  <c:v>DVR</c:v>
                </c:pt>
                <c:pt idx="5">
                  <c:v>HEMA1</c:v>
                </c:pt>
                <c:pt idx="6">
                  <c:v>HEMC</c:v>
                </c:pt>
                <c:pt idx="7">
                  <c:v>HEMD</c:v>
                </c:pt>
                <c:pt idx="8">
                  <c:v>HEME</c:v>
                </c:pt>
                <c:pt idx="9">
                  <c:v>PDS</c:v>
                </c:pt>
                <c:pt idx="10">
                  <c:v>PORA</c:v>
                </c:pt>
                <c:pt idx="11">
                  <c:v>PSY1</c:v>
                </c:pt>
                <c:pt idx="12">
                  <c:v>PSY2</c:v>
                </c:pt>
                <c:pt idx="13">
                  <c:v>PSY3</c:v>
                </c:pt>
              </c:strCache>
              <c:extLst/>
            </c:strRef>
          </c:cat>
          <c:val>
            <c:numRef>
              <c:f>Sheet1!$C$3:$R$3</c:f>
              <c:numCache>
                <c:formatCode>General</c:formatCode>
                <c:ptCount val="14"/>
                <c:pt idx="0">
                  <c:v>0.35860907300383899</c:v>
                </c:pt>
                <c:pt idx="1">
                  <c:v>0.298805222126998</c:v>
                </c:pt>
                <c:pt idx="2">
                  <c:v>0.97427794870205797</c:v>
                </c:pt>
                <c:pt idx="3">
                  <c:v>0.79047284956803299</c:v>
                </c:pt>
                <c:pt idx="4">
                  <c:v>0.14156131398492999</c:v>
                </c:pt>
                <c:pt idx="5">
                  <c:v>0.168216696195921</c:v>
                </c:pt>
                <c:pt idx="6">
                  <c:v>1.6626373079202399</c:v>
                </c:pt>
                <c:pt idx="7">
                  <c:v>0.52530362914028195</c:v>
                </c:pt>
                <c:pt idx="8">
                  <c:v>1.25569910455177</c:v>
                </c:pt>
                <c:pt idx="9">
                  <c:v>0.75615354265643897</c:v>
                </c:pt>
                <c:pt idx="10">
                  <c:v>0.35331114023860799</c:v>
                </c:pt>
                <c:pt idx="11">
                  <c:v>0.28456372648028699</c:v>
                </c:pt>
                <c:pt idx="12">
                  <c:v>0.39090102268777099</c:v>
                </c:pt>
                <c:pt idx="13">
                  <c:v>1.2644528877176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D92B-458C-8A05-C51723DF13BA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953671984"/>
        <c:axId val="953660560"/>
      </c:barChart>
      <c:catAx>
        <c:axId val="953671984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txPr>
          <a:bodyPr/>
          <a:lstStyle/>
          <a:p>
            <a:pPr>
              <a:defRPr sz="10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53660560"/>
        <c:crosses val="autoZero"/>
        <c:auto val="1"/>
        <c:lblAlgn val="ctr"/>
        <c:lblOffset val="100"/>
        <c:noMultiLvlLbl val="0"/>
      </c:catAx>
      <c:valAx>
        <c:axId val="9536605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altLang="zh-CN" b="1">
                    <a:latin typeface="Times New Roman" pitchFamily="18" charset="0"/>
                    <a:cs typeface="Times New Roman" pitchFamily="18" charset="0"/>
                  </a:rPr>
                  <a:t>Ralative Expretion Level</a:t>
                </a:r>
                <a:endParaRPr lang="zh-CN" altLang="en-US" b="1">
                  <a:latin typeface="Times New Roman" pitchFamily="18" charset="0"/>
                  <a:cs typeface="Times New Roman" pitchFamily="18" charset="0"/>
                </a:endParaRPr>
              </a:p>
            </c:rich>
          </c:tx>
          <c:overlay val="0"/>
        </c:title>
        <c:numFmt formatCode="#,##0.0_);[Red]\(#,##0.0\)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53671984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egendEntry>
        <c:idx val="1"/>
        <c:txPr>
          <a:bodyPr/>
          <a:lstStyle/>
          <a:p>
            <a:pPr>
              <a:defRPr i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68918627749865202"/>
          <c:y val="5.8425349916552446E-2"/>
          <c:w val="0.21160864334016471"/>
          <c:h val="7.0431630788853589E-2"/>
        </c:manualLayout>
      </c:layout>
      <c:overlay val="0"/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B90235-E102-4172-90E2-46ACC7BABDEF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0DED98-3A28-44CA-92C1-B87453896C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45650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2438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4550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324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2475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845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3672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5684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5685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2336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5960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7667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3FA9DD-632E-4B62-AE9E-8CA47E138B7E}" type="datetimeFigureOut">
              <a:rPr lang="zh-CN" altLang="en-US" smtClean="0"/>
              <a:t>2022/9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2E11D-7555-4D0E-BA10-16E652F14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2526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图表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9030891"/>
              </p:ext>
            </p:extLst>
          </p:nvPr>
        </p:nvGraphicFramePr>
        <p:xfrm>
          <a:off x="886128" y="4399102"/>
          <a:ext cx="4946110" cy="28160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图表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8939380"/>
              </p:ext>
            </p:extLst>
          </p:nvPr>
        </p:nvGraphicFramePr>
        <p:xfrm>
          <a:off x="778576" y="1282181"/>
          <a:ext cx="5161214" cy="29278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文本框 8"/>
          <p:cNvSpPr txBox="1"/>
          <p:nvPr/>
        </p:nvSpPr>
        <p:spPr>
          <a:xfrm>
            <a:off x="1014948" y="1318803"/>
            <a:ext cx="8496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014948" y="4428137"/>
            <a:ext cx="8496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AFF557C4-4E15-463D-A5F9-C97C2B8B1422}"/>
              </a:ext>
            </a:extLst>
          </p:cNvPr>
          <p:cNvSpPr/>
          <p:nvPr/>
        </p:nvSpPr>
        <p:spPr>
          <a:xfrm>
            <a:off x="368545" y="7404240"/>
            <a:ext cx="642172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attern of photosynthesis and  photosynthetic pigment metabolism related genes between the wild type (WT) and the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sac3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:Expression pattern of photosynthesis related genes between the wild type (WT) and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sac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:Expression pattern of photosynthetic pigment metabolism related genes between the wild type (WT) and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sac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.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7998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21</TotalTime>
  <Words>78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MDPI</cp:lastModifiedBy>
  <cp:revision>241</cp:revision>
  <dcterms:created xsi:type="dcterms:W3CDTF">2021-09-22T09:29:07Z</dcterms:created>
  <dcterms:modified xsi:type="dcterms:W3CDTF">2022-09-21T04:08:45Z</dcterms:modified>
</cp:coreProperties>
</file>